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0424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4447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7236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5855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55362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68670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92780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1233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17268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8456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92005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37198-E914-4956-9A50-75F53E9B802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102A1-34AE-46CE-9CF6-3C5E732743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4406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1">
            <a:extLst>
              <a:ext uri="{FF2B5EF4-FFF2-40B4-BE49-F238E27FC236}">
                <a16:creationId xmlns:a16="http://schemas.microsoft.com/office/drawing/2014/main" xmlns="" id="{4DAE9BDA-46F9-42C6-90E8-B4DD9C2D339F}"/>
              </a:ext>
            </a:extLst>
          </p:cNvPr>
          <p:cNvSpPr txBox="1">
            <a:spLocks/>
          </p:cNvSpPr>
          <p:nvPr/>
        </p:nvSpPr>
        <p:spPr>
          <a:xfrm>
            <a:off x="-228488" y="-2129216"/>
            <a:ext cx="7348065" cy="186680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45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: Additional markers of mTORC1 activity and autophagy</a:t>
            </a:r>
            <a:endParaRPr lang="en-US" sz="84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03F3E877-8E0D-4D04-A61B-7B842550E283}"/>
              </a:ext>
            </a:extLst>
          </p:cNvPr>
          <p:cNvSpPr txBox="1"/>
          <p:nvPr/>
        </p:nvSpPr>
        <p:spPr>
          <a:xfrm>
            <a:off x="100228" y="2216455"/>
            <a:ext cx="290999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xmlns="" id="{B667D2F5-2476-4540-8FEC-F7941A70B0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5100517"/>
              </p:ext>
            </p:extLst>
          </p:nvPr>
        </p:nvGraphicFramePr>
        <p:xfrm>
          <a:off x="417898" y="1976406"/>
          <a:ext cx="2629179" cy="23877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3" imgW="2489804" imgH="2259839" progId="Prism7.Document">
                  <p:embed/>
                </p:oleObj>
              </mc:Choice>
              <mc:Fallback>
                <p:oleObj name="Prism 7" r:id="rId3" imgW="2489804" imgH="225983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7898" y="1976406"/>
                        <a:ext cx="2629179" cy="23877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xmlns="" id="{E81BCF37-A0FD-4D07-82D4-75544611EE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1582285"/>
              </p:ext>
            </p:extLst>
          </p:nvPr>
        </p:nvGraphicFramePr>
        <p:xfrm>
          <a:off x="3047077" y="1965656"/>
          <a:ext cx="3710698" cy="23726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5" imgW="3512434" imgH="2246160" progId="Prism7.Document">
                  <p:embed/>
                </p:oleObj>
              </mc:Choice>
              <mc:Fallback>
                <p:oleObj name="Prism 7" r:id="rId5" imgW="3512434" imgH="224616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47077" y="1965656"/>
                        <a:ext cx="3710698" cy="23726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6">
            <a:extLst>
              <a:ext uri="{FF2B5EF4-FFF2-40B4-BE49-F238E27FC236}">
                <a16:creationId xmlns:a16="http://schemas.microsoft.com/office/drawing/2014/main" xmlns="" id="{7B3326A9-AD28-4FAD-A240-BE08846D72A2}"/>
              </a:ext>
            </a:extLst>
          </p:cNvPr>
          <p:cNvSpPr txBox="1"/>
          <p:nvPr/>
        </p:nvSpPr>
        <p:spPr>
          <a:xfrm>
            <a:off x="290546" y="4917688"/>
            <a:ext cx="6309995" cy="7924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5: Quantification of p16 nuclear staining from IHC of pre- and post-sirolimus treated breast tissues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Quantification of breast tissue from normal (n=12) and DCIS ducts (n=12) of control and sirolimus treated patients for p16 nuclear staining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ignificance was evaluated by 2-way ANOVA.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xmlns="" id="{11CA9B4E-AE7A-C3DF-6F26-D74C54E637BB}"/>
              </a:ext>
            </a:extLst>
          </p:cNvPr>
          <p:cNvSpPr txBox="1">
            <a:spLocks/>
          </p:cNvSpPr>
          <p:nvPr/>
        </p:nvSpPr>
        <p:spPr>
          <a:xfrm>
            <a:off x="297498" y="87323"/>
            <a:ext cx="5679229" cy="1183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112" dirty="0"/>
              <a:t>Supplementary Figure 5: Quantification of p16 nuclear staining from IHC of pre- and post-sirolimus treated breast tissues</a:t>
            </a:r>
          </a:p>
        </p:txBody>
      </p:sp>
    </p:spTree>
    <p:extLst>
      <p:ext uri="{BB962C8B-B14F-4D97-AF65-F5344CB8AC3E}">
        <p14:creationId xmlns:p14="http://schemas.microsoft.com/office/powerpoint/2010/main" val="846586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</vt:vector>
  </TitlesOfParts>
  <Company>HP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Suresh</dc:creator>
  <cp:lastModifiedBy>Saranya Suresh</cp:lastModifiedBy>
  <cp:revision>1</cp:revision>
  <dcterms:created xsi:type="dcterms:W3CDTF">2023-10-11T12:47:05Z</dcterms:created>
  <dcterms:modified xsi:type="dcterms:W3CDTF">2023-10-11T12:47:16Z</dcterms:modified>
</cp:coreProperties>
</file>